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3">
  <p:sldMasterIdLst>
    <p:sldMasterId id="2147483648" r:id="rId1"/>
  </p:sldMasterIdLst>
  <p:notesMasterIdLst>
    <p:notesMasterId r:id="rId11"/>
  </p:notesMasterIdLst>
  <p:sldIdLst>
    <p:sldId id="258" r:id="rId2"/>
    <p:sldId id="256" r:id="rId3"/>
    <p:sldId id="257" r:id="rId4"/>
    <p:sldId id="259" r:id="rId5"/>
    <p:sldId id="260" r:id="rId6"/>
    <p:sldId id="261" r:id="rId7"/>
    <p:sldId id="262" r:id="rId8"/>
    <p:sldId id="263" r:id="rId9"/>
    <p:sldId id="264" r:id="rId10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145" autoAdjust="0"/>
    <p:restoredTop sz="94660"/>
  </p:normalViewPr>
  <p:slideViewPr>
    <p:cSldViewPr snapToGrid="0">
      <p:cViewPr>
        <p:scale>
          <a:sx n="100" d="100"/>
          <a:sy n="100" d="100"/>
        </p:scale>
        <p:origin x="984" y="21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50" d="100"/>
        <a:sy n="150" d="100"/>
      </p:scale>
      <p:origin x="0" y="-948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8DDCE01-4EBA-41BD-8977-8A7D972B52EE}" type="datetimeFigureOut">
              <a:rPr lang="zh-CN" altLang="en-US" smtClean="0"/>
              <a:t>2025/2/13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D17A834-4615-4CE9-892A-407357F26C9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8650787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D17A834-4615-4CE9-892A-407357F26C97}" type="slidenum">
              <a:rPr lang="zh-CN" altLang="en-US" smtClean="0"/>
              <a:t>9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6282020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F73B1E5-42D1-A7BE-E7E2-EE045306C50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D8576840-5D99-0348-C995-7C91F4ADE6A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F7CE1F4-91EB-91EE-3D01-51310EF2F1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0E83A9-D479-4E85-BD1A-6825AE4D997A}" type="datetimeFigureOut">
              <a:rPr lang="zh-CN" altLang="en-US" smtClean="0"/>
              <a:t>2025/2/1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A39937D-767C-A3A0-318B-486A3CFBB7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D417D37-FCB2-EFAF-4D07-F7542D5DB0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7B696B-B3EB-4267-B5E4-0D8285B69AD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199891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F427995-9D5D-5530-0159-51E3B01C4E8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4BC9B519-FA85-81C2-2EB8-A070B1238B0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3B3FE7B-2E96-8F67-A46D-250F044369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0E83A9-D479-4E85-BD1A-6825AE4D997A}" type="datetimeFigureOut">
              <a:rPr lang="zh-CN" altLang="en-US" smtClean="0"/>
              <a:t>2025/2/1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1A338AD-5F17-6907-E8EC-DEA46CBC77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8CBA4D2-B426-A9E7-1640-6D77956C30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7B696B-B3EB-4267-B5E4-0D8285B69AD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14808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0C5868C6-C5DC-7980-EFF5-96C6E97B432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FFE13B20-207E-4582-4A50-EE8D1835C07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5A61906-271E-C9CE-C643-CBD9719710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0E83A9-D479-4E85-BD1A-6825AE4D997A}" type="datetimeFigureOut">
              <a:rPr lang="zh-CN" altLang="en-US" smtClean="0"/>
              <a:t>2025/2/1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0E3A267-41FA-5F0C-511B-317F2C2013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237B816-C225-429A-AD0B-E4DD58B972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7B696B-B3EB-4267-B5E4-0D8285B69AD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445497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88B2B87-DA12-771B-86FC-8D18D70483D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272E8E68-C9D6-0E30-19F0-4A09EDB8B91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7735FD9-4C9D-BB0C-BB37-03C25AB0F9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0E83A9-D479-4E85-BD1A-6825AE4D997A}" type="datetimeFigureOut">
              <a:rPr lang="zh-CN" altLang="en-US" smtClean="0"/>
              <a:t>2025/2/1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3BAD91B-87C8-086C-9461-3AF5B4CD4D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7F81812-FDA9-DF03-7384-FF2E38ADCD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7B696B-B3EB-4267-B5E4-0D8285B69AD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215150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880C41F-0D22-9DD2-1D17-0CF97DCDBD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A8FF88D-47E8-401F-9816-9A15D329A9F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C51349B-BB1E-7396-5616-84B6AD2673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0E83A9-D479-4E85-BD1A-6825AE4D997A}" type="datetimeFigureOut">
              <a:rPr lang="zh-CN" altLang="en-US" smtClean="0"/>
              <a:t>2025/2/1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A3B7704-CF95-3F41-15F1-91992DF2D0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2A87BFF-A30D-310E-0C32-6B8FA4562A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7B696B-B3EB-4267-B5E4-0D8285B69AD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446310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AD8DD91-5851-A38F-F935-21518C30663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DEA740D2-DE9B-253A-2AEC-A5719AE6BDA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04B59E75-C8EF-0928-C32A-6E90FC3D84C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11E6FE9-8586-31B9-9DA2-DEB03001C9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0E83A9-D479-4E85-BD1A-6825AE4D997A}" type="datetimeFigureOut">
              <a:rPr lang="zh-CN" altLang="en-US" smtClean="0"/>
              <a:t>2025/2/1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22853F8-002B-5ABA-4DCA-34F2B73206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43E7025-399C-EEEA-628A-63E5234115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7B696B-B3EB-4267-B5E4-0D8285B69AD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279092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A59CB0B-99D4-BBBF-A845-9B46D0BDE9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74CA5B9-6483-ADC2-6EA3-5A5667F8BAE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C58691A1-0031-A2AA-02B4-99CE5778121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EAA5F9FF-2DAD-BAF6-45C8-1DB3DF96849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DAD24FD7-9BB8-EDEA-ACAC-425A01E2CCC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E03B1512-7BCC-54EC-A9BA-7F2379C115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0E83A9-D479-4E85-BD1A-6825AE4D997A}" type="datetimeFigureOut">
              <a:rPr lang="zh-CN" altLang="en-US" smtClean="0"/>
              <a:t>2025/2/13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AE14BEB8-B193-4361-F324-D5E55E5D9F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C9B1BAF6-BA59-72BE-1A5C-48C40F382A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7B696B-B3EB-4267-B5E4-0D8285B69AD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684456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AE7FB01-4B74-7591-F58B-2D37E527504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498FB625-ABB0-179D-BED3-A96B9A8F6B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0E83A9-D479-4E85-BD1A-6825AE4D997A}" type="datetimeFigureOut">
              <a:rPr lang="zh-CN" altLang="en-US" smtClean="0"/>
              <a:t>2025/2/13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D6DDE29B-063A-1E37-F75B-F642EDF51E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8574D5B4-3498-80A3-AAD4-91E81DCC9D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7B696B-B3EB-4267-B5E4-0D8285B69AD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065690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80342B2F-35E4-A064-CD6F-01B3ECDB83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0E83A9-D479-4E85-BD1A-6825AE4D997A}" type="datetimeFigureOut">
              <a:rPr lang="zh-CN" altLang="en-US" smtClean="0"/>
              <a:t>2025/2/13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5E534A2F-7171-9DCC-3BC7-6D375B3717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34F143E0-6034-BD19-8D14-E33D45E8C2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7B696B-B3EB-4267-B5E4-0D8285B69AD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889048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9AF3DF8-AE61-F757-09B2-E235BF6003F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E37D7177-EA68-7F7F-EBB3-DA0949FDF6E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B60B737B-BEBE-2D91-E39E-D7CD5FE2704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FBAF0C5-D03F-5A14-080D-DF9CCDCC68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0E83A9-D479-4E85-BD1A-6825AE4D997A}" type="datetimeFigureOut">
              <a:rPr lang="zh-CN" altLang="en-US" smtClean="0"/>
              <a:t>2025/2/1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6D75ED13-337D-8C95-4D09-A8C694906D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E07DD708-1733-C710-1838-6D9E138234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7B696B-B3EB-4267-B5E4-0D8285B69AD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578487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CABDF09-149D-D808-943E-A3A6E4876C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4DC4CF77-1D3A-DBFC-CB12-B0EB3B6CDF4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80EB369A-4C86-C4AC-3C1D-4F319037719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6B052F7-95DE-BCCC-44AB-A1D2A82F11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0E83A9-D479-4E85-BD1A-6825AE4D997A}" type="datetimeFigureOut">
              <a:rPr lang="zh-CN" altLang="en-US" smtClean="0"/>
              <a:t>2025/2/1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21A6428-F0B6-BCD0-ED56-352FCAEAC4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B0EBE365-09DB-A488-4F40-E4ACC36FB5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7B696B-B3EB-4267-B5E4-0D8285B69AD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799437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919AB139-DA23-CB3C-F845-5A01B4FF97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14612884-AD4B-12AC-597C-A7A6B60A5C2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50915F5-0168-2319-3314-593FD6F9809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0E83A9-D479-4E85-BD1A-6825AE4D997A}" type="datetimeFigureOut">
              <a:rPr lang="zh-CN" altLang="en-US" smtClean="0"/>
              <a:t>2025/2/1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AE325AF-08FE-4EE7-D8FC-D42D4450E76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7CE3CBB-51E2-0E2B-40E6-01C83322DCA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7B696B-B3EB-4267-B5E4-0D8285B69AD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869187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1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6.png"/><Relationship Id="rId5" Type="http://schemas.openxmlformats.org/officeDocument/2006/relationships/image" Target="../media/image15.png"/><Relationship Id="rId4" Type="http://schemas.openxmlformats.org/officeDocument/2006/relationships/image" Target="../media/image14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9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3.png"/><Relationship Id="rId4" Type="http://schemas.openxmlformats.org/officeDocument/2006/relationships/image" Target="../media/image22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png"/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6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png"/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9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2.png"/><Relationship Id="rId4" Type="http://schemas.openxmlformats.org/officeDocument/2006/relationships/image" Target="../media/image3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>
            <a:extLst>
              <a:ext uri="{FF2B5EF4-FFF2-40B4-BE49-F238E27FC236}">
                <a16:creationId xmlns:a16="http://schemas.microsoft.com/office/drawing/2014/main" id="{37A779B3-8B5A-43B0-6312-DC876420F781}"/>
              </a:ext>
            </a:extLst>
          </p:cNvPr>
          <p:cNvSpPr txBox="1"/>
          <p:nvPr/>
        </p:nvSpPr>
        <p:spPr>
          <a:xfrm>
            <a:off x="3553334" y="5331933"/>
            <a:ext cx="609746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kern="0" dirty="0">
                <a:solidFill>
                  <a:srgbClr val="0A0A0A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Figure S1. HRFABMS spectrum of </a:t>
            </a:r>
            <a:r>
              <a:rPr lang="en-US" altLang="zh-CN" sz="1800" kern="0" dirty="0">
                <a:solidFill>
                  <a:srgbClr val="0A0A0A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etabolite 1</a:t>
            </a:r>
            <a:r>
              <a:rPr lang="en-US" altLang="zh-CN" kern="0" dirty="0">
                <a:solidFill>
                  <a:srgbClr val="0A0A0A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altLang="zh-CN" sz="1800" kern="0" dirty="0">
                <a:solidFill>
                  <a:srgbClr val="0A0A0A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 </a:t>
            </a:r>
            <a:endParaRPr lang="zh-CN" altLang="en-US" dirty="0"/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163CAF3B-BF8A-9726-C84A-7129E556C92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06544" y="460103"/>
            <a:ext cx="9801225" cy="45339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4744721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85664DF3-5CE0-E4FF-A129-1C9D607F67B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93319" y="301450"/>
            <a:ext cx="3718063" cy="2942753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A2B8383E-B35E-5B1E-3289-E91304D403CE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r="2166"/>
          <a:stretch/>
        </p:blipFill>
        <p:spPr>
          <a:xfrm>
            <a:off x="6388630" y="273693"/>
            <a:ext cx="3536080" cy="3042766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2D3AA88E-F763-2B28-A931-162F6C0FCFC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366707" y="3405136"/>
            <a:ext cx="3792458" cy="3070454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1CC318BB-778D-DC35-FB72-B04CF64F3E3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17066" y="3532837"/>
            <a:ext cx="3718063" cy="2942753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EF60B85C-540B-AED9-ECBF-03A0A0150235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574249" y="3371905"/>
            <a:ext cx="3792458" cy="3136917"/>
          </a:xfrm>
          <a:prstGeom prst="rect">
            <a:avLst/>
          </a:prstGeom>
        </p:spPr>
      </p:pic>
      <p:sp>
        <p:nvSpPr>
          <p:cNvPr id="15" name="文本框 14">
            <a:extLst>
              <a:ext uri="{FF2B5EF4-FFF2-40B4-BE49-F238E27FC236}">
                <a16:creationId xmlns:a16="http://schemas.microsoft.com/office/drawing/2014/main" id="{A3BFA337-8620-20E0-60D1-B2DDD9427706}"/>
              </a:ext>
            </a:extLst>
          </p:cNvPr>
          <p:cNvSpPr txBox="1"/>
          <p:nvPr/>
        </p:nvSpPr>
        <p:spPr>
          <a:xfrm>
            <a:off x="2645524" y="6442359"/>
            <a:ext cx="609437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sz="1800" kern="0" dirty="0">
                <a:solidFill>
                  <a:srgbClr val="0A0A0A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2. </a:t>
            </a:r>
            <a:r>
              <a:rPr lang="en-US" altLang="zh-CN" sz="1800" kern="0" baseline="30000" dirty="0">
                <a:solidFill>
                  <a:srgbClr val="0A0A0A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zh-CN" sz="1800" kern="0" dirty="0">
                <a:solidFill>
                  <a:srgbClr val="0A0A0A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 NMR spectra of metabolite 1</a:t>
            </a:r>
            <a:r>
              <a:rPr lang="en-US" altLang="zh-CN" kern="0" dirty="0">
                <a:solidFill>
                  <a:srgbClr val="0A0A0A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altLang="zh-CN" sz="1800" kern="0" dirty="0">
                <a:solidFill>
                  <a:srgbClr val="0A0A0A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" name="直接箭头连接符 2">
            <a:extLst>
              <a:ext uri="{FF2B5EF4-FFF2-40B4-BE49-F238E27FC236}">
                <a16:creationId xmlns:a16="http://schemas.microsoft.com/office/drawing/2014/main" id="{419A992B-653B-062F-D6B4-68F8FA15BA71}"/>
              </a:ext>
            </a:extLst>
          </p:cNvPr>
          <p:cNvCxnSpPr>
            <a:cxnSpLocks/>
          </p:cNvCxnSpPr>
          <p:nvPr/>
        </p:nvCxnSpPr>
        <p:spPr>
          <a:xfrm flipV="1">
            <a:off x="1701209" y="1658679"/>
            <a:ext cx="2222205" cy="1204774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pic>
        <p:nvPicPr>
          <p:cNvPr id="14" name="图片 13">
            <a:extLst>
              <a:ext uri="{FF2B5EF4-FFF2-40B4-BE49-F238E27FC236}">
                <a16:creationId xmlns:a16="http://schemas.microsoft.com/office/drawing/2014/main" id="{B934F1AB-DD05-4F36-A4B4-F96E3588CC82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0490791" y="382410"/>
            <a:ext cx="494833" cy="2686625"/>
          </a:xfrm>
          <a:prstGeom prst="rect">
            <a:avLst/>
          </a:prstGeom>
        </p:spPr>
      </p:pic>
      <p:cxnSp>
        <p:nvCxnSpPr>
          <p:cNvPr id="16" name="直接箭头连接符 15">
            <a:extLst>
              <a:ext uri="{FF2B5EF4-FFF2-40B4-BE49-F238E27FC236}">
                <a16:creationId xmlns:a16="http://schemas.microsoft.com/office/drawing/2014/main" id="{F33B6717-D47A-C16D-AFC2-000E0643D66A}"/>
              </a:ext>
            </a:extLst>
          </p:cNvPr>
          <p:cNvCxnSpPr>
            <a:cxnSpLocks/>
          </p:cNvCxnSpPr>
          <p:nvPr/>
        </p:nvCxnSpPr>
        <p:spPr>
          <a:xfrm flipV="1">
            <a:off x="8366707" y="2045547"/>
            <a:ext cx="1767555" cy="817906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18" name="椭圆 17">
            <a:extLst>
              <a:ext uri="{FF2B5EF4-FFF2-40B4-BE49-F238E27FC236}">
                <a16:creationId xmlns:a16="http://schemas.microsoft.com/office/drawing/2014/main" id="{119B961C-89C5-3A8D-3093-D6F3C321F711}"/>
              </a:ext>
            </a:extLst>
          </p:cNvPr>
          <p:cNvSpPr/>
          <p:nvPr/>
        </p:nvSpPr>
        <p:spPr>
          <a:xfrm>
            <a:off x="10134262" y="369648"/>
            <a:ext cx="1207890" cy="2867437"/>
          </a:xfrm>
          <a:prstGeom prst="ellipse">
            <a:avLst/>
          </a:prstGeom>
          <a:noFill/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pic>
        <p:nvPicPr>
          <p:cNvPr id="22" name="图片 21">
            <a:extLst>
              <a:ext uri="{FF2B5EF4-FFF2-40B4-BE49-F238E27FC236}">
                <a16:creationId xmlns:a16="http://schemas.microsoft.com/office/drawing/2014/main" id="{91106127-4DED-6A54-7B31-8290A38613F2}"/>
              </a:ext>
            </a:extLst>
          </p:cNvPr>
          <p:cNvPicPr>
            <a:picLocks noChangeAspect="1"/>
          </p:cNvPicPr>
          <p:nvPr/>
        </p:nvPicPr>
        <p:blipFill>
          <a:blip r:embed="rId8"/>
          <a:srcRect r="2896"/>
          <a:stretch/>
        </p:blipFill>
        <p:spPr>
          <a:xfrm>
            <a:off x="4097862" y="-564981"/>
            <a:ext cx="908430" cy="3286125"/>
          </a:xfrm>
          <a:prstGeom prst="rect">
            <a:avLst/>
          </a:prstGeom>
        </p:spPr>
      </p:pic>
      <p:sp>
        <p:nvSpPr>
          <p:cNvPr id="23" name="椭圆 22">
            <a:extLst>
              <a:ext uri="{FF2B5EF4-FFF2-40B4-BE49-F238E27FC236}">
                <a16:creationId xmlns:a16="http://schemas.microsoft.com/office/drawing/2014/main" id="{59581C68-2377-033C-0E34-0F1E15AB18EB}"/>
              </a:ext>
            </a:extLst>
          </p:cNvPr>
          <p:cNvSpPr/>
          <p:nvPr/>
        </p:nvSpPr>
        <p:spPr>
          <a:xfrm>
            <a:off x="3923414" y="301450"/>
            <a:ext cx="1382338" cy="2719457"/>
          </a:xfrm>
          <a:prstGeom prst="ellipse">
            <a:avLst/>
          </a:prstGeom>
          <a:noFill/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404762482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5E6E04F1-B1A2-BA84-6841-0148C6650DC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80708" y="1824978"/>
            <a:ext cx="3741096" cy="3208046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C9B43886-41F6-326D-F3B0-FA8A755866D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367720" y="1824978"/>
            <a:ext cx="3613065" cy="3208045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E6F88368-45C1-70B2-7028-2F9A37E5EEB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126700" y="1824977"/>
            <a:ext cx="3565135" cy="3208045"/>
          </a:xfrm>
          <a:prstGeom prst="rect">
            <a:avLst/>
          </a:prstGeom>
        </p:spPr>
      </p:pic>
      <p:sp>
        <p:nvSpPr>
          <p:cNvPr id="11" name="文本框 10">
            <a:extLst>
              <a:ext uri="{FF2B5EF4-FFF2-40B4-BE49-F238E27FC236}">
                <a16:creationId xmlns:a16="http://schemas.microsoft.com/office/drawing/2014/main" id="{6FAD0455-D0B3-6506-5D51-C665FC1A242D}"/>
              </a:ext>
            </a:extLst>
          </p:cNvPr>
          <p:cNvSpPr txBox="1"/>
          <p:nvPr/>
        </p:nvSpPr>
        <p:spPr>
          <a:xfrm>
            <a:off x="3426568" y="5792981"/>
            <a:ext cx="609437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kern="0" dirty="0">
                <a:solidFill>
                  <a:srgbClr val="0A0A0A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3. </a:t>
            </a:r>
            <a:r>
              <a:rPr lang="en-US" altLang="zh-CN" sz="1800" kern="0" baseline="30000" dirty="0">
                <a:solidFill>
                  <a:srgbClr val="0A0A0A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r>
              <a:rPr lang="en-US" altLang="zh-CN" sz="1800" kern="0" dirty="0">
                <a:solidFill>
                  <a:srgbClr val="0A0A0A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 NMR spectra of metabolite 1</a:t>
            </a:r>
            <a:r>
              <a:rPr lang="en-US" altLang="zh-CN" kern="0" dirty="0">
                <a:solidFill>
                  <a:srgbClr val="0A0A0A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altLang="zh-CN" sz="1800" kern="0" dirty="0">
                <a:solidFill>
                  <a:srgbClr val="0A0A0A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3369220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D567570E-B06D-E681-44CC-8EC522DB434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06057" y="77874"/>
            <a:ext cx="2913452" cy="2806003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CD0FE93F-F75E-1592-D198-706B3D1D994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371603" y="77874"/>
            <a:ext cx="2913452" cy="2806003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D3471439-D986-D2FC-D358-FB957C66CC4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657414" y="77875"/>
            <a:ext cx="2913452" cy="2806003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DCC53881-D33E-392B-F9E2-31CBDF5FDE9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281780" y="3017017"/>
            <a:ext cx="2762006" cy="2806003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F227D842-2CC8-A405-9EDB-BBF1450B1DA5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371603" y="3017017"/>
            <a:ext cx="2913451" cy="2806002"/>
          </a:xfrm>
          <a:prstGeom prst="rect">
            <a:avLst/>
          </a:prstGeom>
        </p:spPr>
      </p:pic>
      <p:sp>
        <p:nvSpPr>
          <p:cNvPr id="12" name="文本框 11">
            <a:extLst>
              <a:ext uri="{FF2B5EF4-FFF2-40B4-BE49-F238E27FC236}">
                <a16:creationId xmlns:a16="http://schemas.microsoft.com/office/drawing/2014/main" id="{7D0D727F-3DBB-4886-385B-CB658BBFBCE5}"/>
              </a:ext>
            </a:extLst>
          </p:cNvPr>
          <p:cNvSpPr txBox="1"/>
          <p:nvPr/>
        </p:nvSpPr>
        <p:spPr>
          <a:xfrm>
            <a:off x="3376326" y="6074335"/>
            <a:ext cx="609437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kern="0" dirty="0">
                <a:solidFill>
                  <a:srgbClr val="0A0A0A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4. COSY spectra of metabolite 1</a:t>
            </a:r>
            <a:r>
              <a:rPr lang="en-US" altLang="zh-CN" kern="0" dirty="0">
                <a:solidFill>
                  <a:srgbClr val="0A0A0A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altLang="zh-CN" sz="1800" kern="0" dirty="0">
                <a:solidFill>
                  <a:srgbClr val="0A0A0A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1052143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732C6322-5127-0EAC-5C7D-1D69802DF0A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9608" y="1127926"/>
            <a:ext cx="3454834" cy="3763108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CC1E0493-1F81-7BFE-748F-97E0F20C5EA9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2854"/>
          <a:stretch/>
        </p:blipFill>
        <p:spPr>
          <a:xfrm>
            <a:off x="3916530" y="1127926"/>
            <a:ext cx="3454834" cy="3763108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AC583EBC-785D-FBD0-4DB2-4E3BDF6AB11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717405" y="1188216"/>
            <a:ext cx="3399483" cy="3702818"/>
          </a:xfrm>
          <a:prstGeom prst="rect">
            <a:avLst/>
          </a:prstGeom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960DF70B-11DB-15A7-F2D0-9E4E52215D1D}"/>
              </a:ext>
            </a:extLst>
          </p:cNvPr>
          <p:cNvSpPr txBox="1"/>
          <p:nvPr/>
        </p:nvSpPr>
        <p:spPr>
          <a:xfrm>
            <a:off x="3499418" y="5300452"/>
            <a:ext cx="609437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kern="0" dirty="0">
                <a:solidFill>
                  <a:srgbClr val="0A0A0A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5. Edited HSQC spectra of metabolite 1</a:t>
            </a:r>
            <a:r>
              <a:rPr lang="en-US" altLang="zh-CN" kern="0" dirty="0">
                <a:solidFill>
                  <a:srgbClr val="0A0A0A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altLang="zh-CN" sz="1800" kern="0" dirty="0">
                <a:solidFill>
                  <a:srgbClr val="0A0A0A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946117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E3131F11-190E-3FF1-802C-10311C7B1BA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0445" y="792342"/>
            <a:ext cx="2966503" cy="3068515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D4D1AA3C-04FC-A07F-DA20-42E0299CF07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129497" y="774863"/>
            <a:ext cx="2966503" cy="3085994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E757DE34-1457-034F-889F-6E9259F20D0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178550" y="774863"/>
            <a:ext cx="2966503" cy="3085994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E8246F27-A349-ED89-C089-DD0FE300507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145053" y="774863"/>
            <a:ext cx="2966503" cy="3085994"/>
          </a:xfrm>
          <a:prstGeom prst="rect">
            <a:avLst/>
          </a:prstGeom>
        </p:spPr>
      </p:pic>
      <p:sp>
        <p:nvSpPr>
          <p:cNvPr id="12" name="文本框 11">
            <a:extLst>
              <a:ext uri="{FF2B5EF4-FFF2-40B4-BE49-F238E27FC236}">
                <a16:creationId xmlns:a16="http://schemas.microsoft.com/office/drawing/2014/main" id="{7CC2F900-1F32-151E-0CDF-2DFD4B03AA3C}"/>
              </a:ext>
            </a:extLst>
          </p:cNvPr>
          <p:cNvSpPr txBox="1"/>
          <p:nvPr/>
        </p:nvSpPr>
        <p:spPr>
          <a:xfrm>
            <a:off x="3745602" y="4931175"/>
            <a:ext cx="609437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kern="0" dirty="0">
                <a:solidFill>
                  <a:srgbClr val="0A0A0A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6. </a:t>
            </a:r>
            <a:r>
              <a:rPr lang="en-US" altLang="zh-CN" kern="0" dirty="0">
                <a:solidFill>
                  <a:srgbClr val="0A0A0A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MBC </a:t>
            </a:r>
            <a:r>
              <a:rPr lang="en-US" altLang="zh-CN" sz="1800" kern="0" dirty="0">
                <a:solidFill>
                  <a:srgbClr val="0A0A0A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pectra of metabolite 1</a:t>
            </a:r>
            <a:r>
              <a:rPr lang="en-US" altLang="zh-CN" kern="0" dirty="0">
                <a:solidFill>
                  <a:srgbClr val="0A0A0A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altLang="zh-CN" sz="1800" kern="0" dirty="0">
                <a:solidFill>
                  <a:srgbClr val="0A0A0A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9082162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7140049-89D9-961A-DF45-B08D608FD3C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402953E0-53F6-BE98-42A7-B515D1A09FA5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2178" t="2563" b="1153"/>
          <a:stretch/>
        </p:blipFill>
        <p:spPr>
          <a:xfrm>
            <a:off x="536331" y="1274884"/>
            <a:ext cx="3639770" cy="2980592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7CCB4521-313D-7443-1908-F2DAFC20D7D7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539" t="3718" r="935"/>
          <a:stretch/>
        </p:blipFill>
        <p:spPr>
          <a:xfrm>
            <a:off x="4466495" y="1274884"/>
            <a:ext cx="3639770" cy="2980592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16CACA54-020A-8167-9B2B-BD2307F2420D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3086" t="3718" r="934"/>
          <a:stretch/>
        </p:blipFill>
        <p:spPr>
          <a:xfrm>
            <a:off x="8220808" y="1274885"/>
            <a:ext cx="3639770" cy="2980592"/>
          </a:xfrm>
          <a:prstGeom prst="rect">
            <a:avLst/>
          </a:prstGeom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C0DEB181-6A14-88FF-DEEE-AD38B9D7C59E}"/>
              </a:ext>
            </a:extLst>
          </p:cNvPr>
          <p:cNvSpPr txBox="1"/>
          <p:nvPr/>
        </p:nvSpPr>
        <p:spPr>
          <a:xfrm>
            <a:off x="3745602" y="4931175"/>
            <a:ext cx="609437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kern="0" dirty="0">
                <a:solidFill>
                  <a:srgbClr val="0A0A0A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7. </a:t>
            </a:r>
            <a:r>
              <a:rPr lang="en-US" altLang="zh-CN" kern="0" dirty="0">
                <a:solidFill>
                  <a:srgbClr val="0A0A0A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EPT45 </a:t>
            </a:r>
            <a:r>
              <a:rPr lang="en-US" altLang="zh-CN" sz="1800" kern="0" dirty="0">
                <a:solidFill>
                  <a:srgbClr val="0A0A0A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pectra of metabolite 1</a:t>
            </a:r>
            <a:r>
              <a:rPr lang="en-US" altLang="zh-CN" kern="0" dirty="0">
                <a:solidFill>
                  <a:srgbClr val="0A0A0A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altLang="zh-CN" sz="1800" kern="0" dirty="0">
                <a:solidFill>
                  <a:srgbClr val="0A0A0A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1280020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CC4F2B4-BCF2-90B2-78DC-C272CBE5728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58588B79-81DD-C908-A092-044E9235D141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2957" t="3974"/>
          <a:stretch/>
        </p:blipFill>
        <p:spPr>
          <a:xfrm>
            <a:off x="413241" y="1059711"/>
            <a:ext cx="3499337" cy="2878930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F0F935A0-6CF7-BAC3-DC2A-1F17183AC1AE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1444" t="3846" r="1088"/>
          <a:stretch/>
        </p:blipFill>
        <p:spPr>
          <a:xfrm>
            <a:off x="4237893" y="1059711"/>
            <a:ext cx="3499337" cy="2878930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95F421D6-DE4D-3595-F851-AD126B4A13BE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2430" t="5067"/>
          <a:stretch/>
        </p:blipFill>
        <p:spPr>
          <a:xfrm>
            <a:off x="8132885" y="1059711"/>
            <a:ext cx="3499338" cy="2878930"/>
          </a:xfrm>
          <a:prstGeom prst="rect">
            <a:avLst/>
          </a:prstGeom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8BFA416A-F9FB-3B8A-DFEA-CEB133F9BE3E}"/>
              </a:ext>
            </a:extLst>
          </p:cNvPr>
          <p:cNvSpPr txBox="1"/>
          <p:nvPr/>
        </p:nvSpPr>
        <p:spPr>
          <a:xfrm>
            <a:off x="3745602" y="4931175"/>
            <a:ext cx="609437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kern="0" dirty="0">
                <a:solidFill>
                  <a:srgbClr val="0A0A0A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8. </a:t>
            </a:r>
            <a:r>
              <a:rPr lang="en-US" altLang="zh-CN" kern="0" dirty="0">
                <a:solidFill>
                  <a:srgbClr val="0A0A0A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EPT90 </a:t>
            </a:r>
            <a:r>
              <a:rPr lang="en-US" altLang="zh-CN" sz="1800" kern="0" dirty="0">
                <a:solidFill>
                  <a:srgbClr val="0A0A0A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pectra of metabolite 1</a:t>
            </a:r>
            <a:r>
              <a:rPr lang="en-US" altLang="zh-CN" kern="0" dirty="0">
                <a:solidFill>
                  <a:srgbClr val="0A0A0A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altLang="zh-CN" sz="1800" kern="0" dirty="0">
                <a:solidFill>
                  <a:srgbClr val="0A0A0A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6689561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7EF5E70-8C91-1BB8-4369-D4E40695D2A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96CB8D5C-91D4-BEC6-1400-8639FD3AFFBF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1743" t="4231" r="939"/>
          <a:stretch/>
        </p:blipFill>
        <p:spPr>
          <a:xfrm>
            <a:off x="896816" y="896816"/>
            <a:ext cx="3344608" cy="3162418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5926133E-3611-F11D-C98B-30D989B9F277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t="3857"/>
          <a:stretch/>
        </p:blipFill>
        <p:spPr>
          <a:xfrm>
            <a:off x="4241423" y="903805"/>
            <a:ext cx="3344608" cy="3178228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E115B84A-2CB1-92C2-AB27-D06F578376F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950578" y="825166"/>
            <a:ext cx="3344606" cy="3234068"/>
          </a:xfrm>
          <a:prstGeom prst="rect">
            <a:avLst/>
          </a:prstGeom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F6CB7658-BC79-61C3-5045-8941987A57EB}"/>
              </a:ext>
            </a:extLst>
          </p:cNvPr>
          <p:cNvSpPr txBox="1"/>
          <p:nvPr/>
        </p:nvSpPr>
        <p:spPr>
          <a:xfrm>
            <a:off x="3745602" y="4931175"/>
            <a:ext cx="609437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kern="0" dirty="0">
                <a:solidFill>
                  <a:srgbClr val="0A0A0A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8. </a:t>
            </a:r>
            <a:r>
              <a:rPr lang="en-US" altLang="zh-CN" kern="0" dirty="0">
                <a:solidFill>
                  <a:srgbClr val="0A0A0A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EPT90 </a:t>
            </a:r>
            <a:r>
              <a:rPr lang="en-US" altLang="zh-CN" sz="1800" kern="0" dirty="0">
                <a:solidFill>
                  <a:srgbClr val="0A0A0A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pectra of metabolite 1</a:t>
            </a:r>
            <a:r>
              <a:rPr lang="en-US" altLang="zh-CN" kern="0" dirty="0">
                <a:solidFill>
                  <a:srgbClr val="0A0A0A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altLang="zh-CN" sz="1800" kern="0" dirty="0">
                <a:solidFill>
                  <a:srgbClr val="0A0A0A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817981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28</TotalTime>
  <Words>85</Words>
  <Application>Microsoft Office PowerPoint</Application>
  <PresentationFormat>Widescreen</PresentationFormat>
  <Paragraphs>10</Paragraphs>
  <Slides>9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4" baseType="lpstr">
      <vt:lpstr>等线</vt:lpstr>
      <vt:lpstr>等线 Light</vt:lpstr>
      <vt:lpstr>Arial</vt:lpstr>
      <vt:lpstr>Times New Roman</vt:lpstr>
      <vt:lpstr>Office 主题​​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eyuxiaojun@163.com</dc:creator>
  <cp:lastModifiedBy>MDPI</cp:lastModifiedBy>
  <cp:revision>14</cp:revision>
  <dcterms:created xsi:type="dcterms:W3CDTF">2025-01-16T07:14:05Z</dcterms:created>
  <dcterms:modified xsi:type="dcterms:W3CDTF">2025-02-13T07:29:52Z</dcterms:modified>
</cp:coreProperties>
</file>